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8" r:id="rId6"/>
    <p:sldId id="269" r:id="rId7"/>
    <p:sldId id="270" r:id="rId8"/>
    <p:sldId id="260" r:id="rId9"/>
    <p:sldId id="261" r:id="rId10"/>
    <p:sldId id="266" r:id="rId11"/>
    <p:sldId id="267" r:id="rId12"/>
    <p:sldId id="262" r:id="rId13"/>
    <p:sldId id="263" r:id="rId14"/>
    <p:sldId id="264" r:id="rId15"/>
    <p:sldId id="265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A44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88" autoAdjust="0"/>
  </p:normalViewPr>
  <p:slideViewPr>
    <p:cSldViewPr>
      <p:cViewPr>
        <p:scale>
          <a:sx n="94" d="100"/>
          <a:sy n="94" d="100"/>
        </p:scale>
        <p:origin x="-128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jpe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12" Type="http://schemas.microsoft.com/office/2007/relationships/hdphoto" Target="../media/hdphoto8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openxmlformats.org/officeDocument/2006/relationships/image" Target="../media/image16.png"/><Relationship Id="rId5" Type="http://schemas.microsoft.com/office/2007/relationships/hdphoto" Target="../media/hdphoto5.wdp"/><Relationship Id="rId10" Type="http://schemas.openxmlformats.org/officeDocument/2006/relationships/image" Target="../media/image15.jpeg"/><Relationship Id="rId4" Type="http://schemas.openxmlformats.org/officeDocument/2006/relationships/image" Target="../media/image12.png"/><Relationship Id="rId9" Type="http://schemas.microsoft.com/office/2007/relationships/hdphoto" Target="../media/hdphoto7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3" Type="http://schemas.microsoft.com/office/2007/relationships/hdphoto" Target="../media/hdphoto9.wdp"/><Relationship Id="rId7" Type="http://schemas.microsoft.com/office/2007/relationships/hdphoto" Target="../media/hdphoto11.wdp"/><Relationship Id="rId12" Type="http://schemas.microsoft.com/office/2007/relationships/hdphoto" Target="../media/hdphoto13.wdp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2.png"/><Relationship Id="rId5" Type="http://schemas.microsoft.com/office/2007/relationships/hdphoto" Target="../media/hdphoto10.wdp"/><Relationship Id="rId10" Type="http://schemas.microsoft.com/office/2007/relationships/hdphoto" Target="../media/hdphoto12.wdp"/><Relationship Id="rId4" Type="http://schemas.openxmlformats.org/officeDocument/2006/relationships/image" Target="../media/image18.png"/><Relationship Id="rId9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:\flash drive\Control EBs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1653" y="773428"/>
            <a:ext cx="2895600" cy="2171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E:\mom5538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113" y="773430"/>
            <a:ext cx="2895597" cy="21716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E:\mom5312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" t="236" r="380" b="527"/>
          <a:stretch/>
        </p:blipFill>
        <p:spPr bwMode="auto">
          <a:xfrm>
            <a:off x="4690113" y="2971800"/>
            <a:ext cx="2895597" cy="2174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che9ff\Desktop\Control--neuron rosettes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167" t="16273" r="11675" b="19504"/>
          <a:stretch/>
        </p:blipFill>
        <p:spPr bwMode="auto">
          <a:xfrm>
            <a:off x="1759869" y="2971800"/>
            <a:ext cx="2907384" cy="2174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111240" y="6129051"/>
            <a:ext cx="285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71650" y="2701290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EB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71650" y="4901386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NR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01540" y="2733496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 EB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01540" y="4888230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06830" y="662940"/>
            <a:ext cx="45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95400" y="2853690"/>
            <a:ext cx="45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95895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676334" y="1371657"/>
            <a:ext cx="5791266" cy="3809943"/>
            <a:chOff x="2197023" y="1383448"/>
            <a:chExt cx="4835405" cy="380994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1" t="7081" r="3059" b="4170"/>
            <a:stretch/>
          </p:blipFill>
          <p:spPr bwMode="auto">
            <a:xfrm>
              <a:off x="2365178" y="1600199"/>
              <a:ext cx="4667250" cy="35814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 rot="16200000">
              <a:off x="433389" y="3147082"/>
              <a:ext cx="3809943" cy="28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Percentage of positive signals vs. DAPI</a:t>
              </a:r>
              <a:endParaRPr lang="en-US" sz="16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638800" y="2286000"/>
              <a:ext cx="4572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8" name="Right Bracket 7"/>
          <p:cNvSpPr/>
          <p:nvPr/>
        </p:nvSpPr>
        <p:spPr>
          <a:xfrm rot="16200000">
            <a:off x="3476625" y="1281396"/>
            <a:ext cx="304800" cy="762000"/>
          </a:xfrm>
          <a:prstGeom prst="rightBracket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                                      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970036" y="1240318"/>
            <a:ext cx="13179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P= 0.084</a:t>
            </a:r>
            <a:endParaRPr lang="en-US" sz="1400" b="1" dirty="0"/>
          </a:p>
        </p:txBody>
      </p:sp>
      <p:sp>
        <p:nvSpPr>
          <p:cNvPr id="10" name="Right Bracket 9"/>
          <p:cNvSpPr/>
          <p:nvPr/>
        </p:nvSpPr>
        <p:spPr>
          <a:xfrm rot="16200000">
            <a:off x="5726289" y="3005421"/>
            <a:ext cx="304800" cy="762000"/>
          </a:xfrm>
          <a:prstGeom prst="rightBracket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                                      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219700" y="2964343"/>
            <a:ext cx="13179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P= 0.076</a:t>
            </a:r>
            <a:endParaRPr lang="en-US" sz="1400" b="1" dirty="0"/>
          </a:p>
        </p:txBody>
      </p:sp>
      <p:sp>
        <p:nvSpPr>
          <p:cNvPr id="2" name="Rounded Rectangle 1"/>
          <p:cNvSpPr/>
          <p:nvPr/>
        </p:nvSpPr>
        <p:spPr>
          <a:xfrm>
            <a:off x="5878688" y="1662395"/>
            <a:ext cx="1588912" cy="1301948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2" name="Group 11"/>
          <p:cNvGrpSpPr/>
          <p:nvPr/>
        </p:nvGrpSpPr>
        <p:grpSpPr>
          <a:xfrm>
            <a:off x="5181600" y="1538571"/>
            <a:ext cx="3015341" cy="1077218"/>
            <a:chOff x="4310743" y="3037112"/>
            <a:chExt cx="3015341" cy="1077218"/>
          </a:xfrm>
        </p:grpSpPr>
        <p:pic>
          <p:nvPicPr>
            <p:cNvPr id="1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14" t="27909" r="25684" b="58816"/>
            <a:stretch/>
          </p:blipFill>
          <p:spPr bwMode="auto">
            <a:xfrm>
              <a:off x="4310743" y="3535562"/>
              <a:ext cx="185057" cy="5356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4430484" y="3037112"/>
              <a:ext cx="2895600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Control BRN3a/DAPI</a:t>
              </a:r>
            </a:p>
            <a:p>
              <a:r>
                <a:rPr lang="en-US" sz="1600" b="1" dirty="0" smtClean="0"/>
                <a:t>VO </a:t>
              </a:r>
              <a:r>
                <a:rPr lang="en-US" sz="1600" b="1" dirty="0"/>
                <a:t>BRN3a/DAPI</a:t>
              </a:r>
            </a:p>
            <a:p>
              <a:r>
                <a:rPr lang="en-US" sz="1600" b="1" dirty="0"/>
                <a:t>Control </a:t>
              </a:r>
              <a:r>
                <a:rPr lang="en-US" sz="1600" b="1" dirty="0" smtClean="0"/>
                <a:t>ISLET-1/DAPI</a:t>
              </a:r>
              <a:endParaRPr lang="en-US" sz="1600" b="1" dirty="0"/>
            </a:p>
            <a:p>
              <a:r>
                <a:rPr lang="en-US" sz="1600" b="1" dirty="0" smtClean="0"/>
                <a:t>VO </a:t>
              </a:r>
              <a:r>
                <a:rPr lang="en-US" sz="1600" b="1" dirty="0" smtClean="0"/>
                <a:t>ISLET-1/DAPI</a:t>
              </a:r>
              <a:endParaRPr lang="en-US" sz="1600" b="1" dirty="0"/>
            </a:p>
          </p:txBody>
        </p:sp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14" t="12590" r="25684" b="75867"/>
            <a:stretch/>
          </p:blipFill>
          <p:spPr bwMode="auto">
            <a:xfrm>
              <a:off x="4310743" y="3124200"/>
              <a:ext cx="185057" cy="4657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7407717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9229" y="2438400"/>
            <a:ext cx="83820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RGC differentiation efficiency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ulture medium used for RGC differentiation contained 10% neural induction medium. Samples were normalized to the Control BRN3a/DAPI staining or the Control ISLET-1/DAPI staining. The number of BRN3a or ISLET-1 signals versus the number of DAPI signals was calculated. A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 of 0.084 was obtained for the BRN3a signal comparison between the Control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 of 0.076 was obtained for the ISLET-1 signal comparison between the Control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ent’s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 was used to analyze differences between two groups.</a:t>
            </a:r>
          </a:p>
        </p:txBody>
      </p:sp>
    </p:spTree>
    <p:extLst>
      <p:ext uri="{BB962C8B-B14F-4D97-AF65-F5344CB8AC3E}">
        <p14:creationId xmlns:p14="http://schemas.microsoft.com/office/powerpoint/2010/main" val="6377038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che9ff\Desktop\12-28-2014\Olivia-Noggin-Brn3a-28\Olivia-Noggin-Brn3a-28_c2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24" y="94869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che9ff\Desktop\12-28-2014\Olivia-Noggin-Brn3a-28\Olivia-Noggin-Brn3a-28_c1.BMP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6346" y="94488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che9ff\Desktop\12-28-2014\Olivia-Noggin-Brn3a-28\Olivia-Noggin-Brn3a-28_(c1+c2+c3).BMP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5168" y="95250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che9ff\Desktop\12-28-2014\Olivia-Noggin-Islet1-1\Olivia-Noggin-Islet1-1_c2.BMP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24" y="320421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che9ff\Desktop\12-28-2014\Olivia-Noggin-Islet1-1\Olivia-Noggin-Islet1-1_c1.BMP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6347" y="320421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che9ff\Desktop\12-28-2014\Olivia-Noggin-Islet1-1\Olivia-Noggin-Islet1-1_(c1+c2+c3).BMP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5170" y="3204210"/>
            <a:ext cx="2974658" cy="22402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3820" y="289560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67050" y="289560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79056" y="2895600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9044" y="515112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67050" y="515112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79056" y="5151120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7244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1000" y="2136339"/>
            <a:ext cx="8382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Noggin rescued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  <a:r>
              <a:rPr lang="en-US" sz="14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L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ion into RGCs confirmed by IF.</a:t>
            </a: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ur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s were cultured with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dium containing 10% FBS and 100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g/mL Noggin to obtai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n rosettes, followed by culturing putative RGCs with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dium containing 10% FBS, DAPT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100 ng/mL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ggin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fixed with 4% PFA on day 31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per panel shows IF staining of TUJ-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 and BRN3a 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),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reas lower panel shows staining of TUJ-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 and ISLET1 (red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en-US" sz="14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e scale 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rs equal 50 µM in both panels.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72912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che9ff\Desktop\12-28-2014\Olivia-2E-Brn3a-1\Olivia-2E-Brn3a-1_c2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630" y="88392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che9ff\Desktop\12-28-2014\Olivia-2E-Brn3a-1\Olivia-2E-Brn3a-1_c1.BMP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8972" y="883920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che9ff\Desktop\12-28-2014\Olivia-2E-Brn3a-1\Olivia-2E-Brn3a-1_(c1+c2+c3).BMP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6504" y="887186"/>
            <a:ext cx="2989912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che9ff\Desktop\12-28-2014\Olivia-2E-Islet1-1\Olivia-2E-Islet1-1_c2.BMP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50" y="3135629"/>
            <a:ext cx="2985392" cy="22484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C:\Users\che9ff\Desktop\12-28-2014\Olivia-2E-Islet1-1\Olivia-2E-Islet1-1_c1.BMP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9910" y="3141980"/>
            <a:ext cx="2988975" cy="22440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C:\Users\che9ff\Desktop\12-28-2014\Olivia-2E-Islet1-1\Olivia-2E-Islet1-1_(c1+c2+c3).BMP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9770" y="3135630"/>
            <a:ext cx="2986646" cy="2240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06680" y="281940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89910" y="281940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101916" y="2830286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1018" y="507492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89910" y="507492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112802" y="5064034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68866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2133600"/>
            <a:ext cx="85344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Addition of 17</a:t>
            </a:r>
            <a:r>
              <a:rPr lang="en-US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estradiol in RGC differentiation medium promoted generation of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  <a:r>
              <a:rPr lang="en-US" sz="14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GCs-OL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RGC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incubated with 1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r>
              <a:rPr lang="el-G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radiol in the cell culture medium during all of the differentiatio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ges, followed by fixation on day 31.  Upper panel shows IF staining against TUJ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 and BRN3a (red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Lower panel shows TUJ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LET-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d)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qual 50 µM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3037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7200" y="2438400"/>
            <a:ext cx="82296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  <a:r>
              <a:rPr lang="en-US" sz="14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</a:t>
            </a:r>
            <a:r>
              <a:rPr lang="en-US" sz="14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) 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unfavorabl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e into neural rosette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 conditions were the same with those of in Figure 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el A show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EBs, which were derived from Control 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Morphologically Olivia EBs look similar to Control EBs. Panel B shows neuron rosettes (NRs) after 5 days o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B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tachment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wer and smaller neuron rosettes were derived from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Bs, compared with neuron rosettes from Control EBs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4834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111240" y="6129051"/>
            <a:ext cx="2858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2" name="Picture 4" descr="C:\Users\che9ff\Desktop\12-28-2014\Olivia-O-Brn3a-7\Olivia-O-Brn3a-7_(c1+c2+c3)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6803" y="826770"/>
            <a:ext cx="2949233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che9ff\Desktop\12-28-2014\Olivia-O-Brn3a-7\Olivia-O-Brn3a-7_c2.BMP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826770"/>
            <a:ext cx="2949233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che9ff\Desktop\12-28-2014\Olivia-O-Brn3a-7\Olivia-O-Brn3a-7_c1.BMP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105" y="826770"/>
            <a:ext cx="2949233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che9ff\Desktop\12-28-2014\Olivia-O-ISLET1-1\Olivia-O-ISLET1-1_(c1+c2+c3).BMP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6803" y="3048000"/>
            <a:ext cx="2953043" cy="22126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che9ff\Desktop\12-28-2014\Olivia-O-ISLET1-1\Olivia-O-ISLET1-1_c1.BMP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4892" y="3048000"/>
            <a:ext cx="2953042" cy="22126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che9ff\Desktop\12-28-2014\Olivia-O-ISLET1-1\Olivia-O-ISLET1-1_c2.BMP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048000"/>
            <a:ext cx="2949233" cy="22126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52400" y="495300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24200" y="495300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055652" y="4953000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52400" y="2740223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24200" y="2740223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055652" y="2740223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8556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2136339"/>
            <a:ext cx="83820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  <a:r>
              <a:rPr lang="en-US" sz="14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s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L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iled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differentiate into RGCs with culture medium supplemented with 10% FBS and DAPT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ion metho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was followed. Putative RGCs were fixed on day 24 before fixation, followed by IF staining. </a:t>
            </a:r>
            <a:r>
              <a:rPr lang="en-US" sz="14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U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per panel shows </a:t>
            </a:r>
            <a:r>
              <a:rPr lang="en-US" altLang="en-US" sz="1400" dirty="0" err="1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tainings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of </a:t>
            </a:r>
            <a:r>
              <a:rPr lang="en-US" altLang="en-US" sz="14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UJ1 (green) and BRN3a (red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), while lower panel displays </a:t>
            </a:r>
            <a:r>
              <a:rPr lang="en-US" altLang="en-US" sz="1400" dirty="0" err="1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tainings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of </a:t>
            </a:r>
            <a:r>
              <a:rPr lang="en-US" altLang="en-US" sz="14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UJ1 (green) and ISLET1 (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ed)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s equal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.</a:t>
            </a:r>
          </a:p>
        </p:txBody>
      </p:sp>
    </p:spTree>
    <p:extLst>
      <p:ext uri="{BB962C8B-B14F-4D97-AF65-F5344CB8AC3E}">
        <p14:creationId xmlns:p14="http://schemas.microsoft.com/office/powerpoint/2010/main" val="18015669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150427" y="80817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TUJ-1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830320" y="80393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BRN3a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504494" y="80481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Merged</a:t>
            </a:r>
            <a:endParaRPr lang="en-US" b="1" dirty="0"/>
          </a:p>
        </p:txBody>
      </p:sp>
      <p:grpSp>
        <p:nvGrpSpPr>
          <p:cNvPr id="36" name="Group 35"/>
          <p:cNvGrpSpPr/>
          <p:nvPr/>
        </p:nvGrpSpPr>
        <p:grpSpPr>
          <a:xfrm>
            <a:off x="370185" y="1191071"/>
            <a:ext cx="8392815" cy="3838129"/>
            <a:chOff x="218244" y="1146630"/>
            <a:chExt cx="8392815" cy="3838129"/>
          </a:xfrm>
        </p:grpSpPr>
        <p:sp>
          <p:nvSpPr>
            <p:cNvPr id="10" name="TextBox 9"/>
            <p:cNvSpPr txBox="1"/>
            <p:nvPr/>
          </p:nvSpPr>
          <p:spPr>
            <a:xfrm rot="16200000">
              <a:off x="-160970" y="3829770"/>
              <a:ext cx="1127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V0</a:t>
              </a:r>
              <a:endParaRPr lang="en-US" b="1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157342" y="1903147"/>
              <a:ext cx="1127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Control</a:t>
              </a:r>
              <a:endParaRPr lang="en-US" b="1" dirty="0"/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565700" y="1146631"/>
              <a:ext cx="2670869" cy="1889626"/>
              <a:chOff x="972432" y="1146630"/>
              <a:chExt cx="2670869" cy="1893987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000685" y="1146630"/>
                <a:ext cx="2642616" cy="1892808"/>
                <a:chOff x="1000685" y="1146630"/>
                <a:chExt cx="2642616" cy="1892808"/>
              </a:xfrm>
            </p:grpSpPr>
            <p:pic>
              <p:nvPicPr>
                <p:cNvPr id="6149" name="Picture 5" descr="C:\Users\che9ff\Dropbox\Normal RGCs with Green Tuj1 and Red Brn3a--1\Normal RGCs with Green Tuj1 and Red Brn3a--1_Alexa 488.JPG"/>
                <p:cNvPicPr preferRelativeResize="0">
                  <a:picLocks noChangeArrowheads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00685" y="1146630"/>
                  <a:ext cx="2642616" cy="18928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15" name="Straight Connector 14"/>
                <p:cNvCxnSpPr/>
                <p:nvPr/>
              </p:nvCxnSpPr>
              <p:spPr>
                <a:xfrm>
                  <a:off x="3124200" y="2895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TextBox 28"/>
              <p:cNvSpPr txBox="1"/>
              <p:nvPr/>
            </p:nvSpPr>
            <p:spPr>
              <a:xfrm>
                <a:off x="972432" y="2763618"/>
                <a:ext cx="26399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J-1</a:t>
                </a:r>
                <a:endPara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3269454" y="1146630"/>
              <a:ext cx="2642616" cy="1890352"/>
              <a:chOff x="3647608" y="1146630"/>
              <a:chExt cx="2650279" cy="1890352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647608" y="1146630"/>
                <a:ext cx="2646650" cy="1889626"/>
                <a:chOff x="3647608" y="1146630"/>
                <a:chExt cx="2646650" cy="1889626"/>
              </a:xfrm>
            </p:grpSpPr>
            <p:pic>
              <p:nvPicPr>
                <p:cNvPr id="6150" name="Picture 6" descr="C:\Users\che9ff\Dropbox\Normal RGCs with Green Tuj1 and Red Brn3a--1\Normal RGCs with Green Tuj1 and Red Brn3a--1_Texasred.JPG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47608" y="1146630"/>
                  <a:ext cx="2646650" cy="188962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17" name="Straight Connector 16"/>
                <p:cNvCxnSpPr/>
                <p:nvPr/>
              </p:nvCxnSpPr>
              <p:spPr>
                <a:xfrm>
                  <a:off x="5791200" y="2895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TextBox 29"/>
              <p:cNvSpPr txBox="1"/>
              <p:nvPr/>
            </p:nvSpPr>
            <p:spPr>
              <a:xfrm>
                <a:off x="3653747" y="2759983"/>
                <a:ext cx="26441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N3a</a:t>
                </a:r>
                <a:endPara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5940369" y="1147763"/>
              <a:ext cx="2643642" cy="1890711"/>
              <a:chOff x="6323286" y="1143000"/>
              <a:chExt cx="2643642" cy="1890711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6323286" y="1143000"/>
                <a:ext cx="2643642" cy="1889626"/>
                <a:chOff x="6323286" y="1143000"/>
                <a:chExt cx="2643642" cy="1889626"/>
              </a:xfrm>
            </p:grpSpPr>
            <p:pic>
              <p:nvPicPr>
                <p:cNvPr id="6151" name="Picture 7" descr="C:\Users\che9ff\Dropbox\Normal RGCs with Green Tuj1 and Red Brn3a--1\Normal RGCs with Green Tuj1 and Red Brn3a--1_(Texasred+Alexa 488+DAPI).JPG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323286" y="1143000"/>
                  <a:ext cx="2643642" cy="188962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18" name="Straight Connector 17"/>
                <p:cNvCxnSpPr/>
                <p:nvPr/>
              </p:nvCxnSpPr>
              <p:spPr>
                <a:xfrm>
                  <a:off x="8458200" y="2895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TextBox 30"/>
              <p:cNvSpPr txBox="1"/>
              <p:nvPr/>
            </p:nvSpPr>
            <p:spPr>
              <a:xfrm>
                <a:off x="6323286" y="2756712"/>
                <a:ext cx="26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J-1 </a:t>
                </a:r>
                <a:r>
                  <a:rPr lang="en-US" sz="12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 </a:t>
                </a:r>
                <a:r>
                  <a:rPr lang="en-US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N3a / </a:t>
                </a:r>
                <a:r>
                  <a:rPr lang="en-US" sz="1200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12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596341" y="3064860"/>
              <a:ext cx="2642616" cy="1895046"/>
              <a:chOff x="969732" y="3069623"/>
              <a:chExt cx="2642616" cy="1895046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969732" y="3069623"/>
                <a:ext cx="2642616" cy="1892808"/>
                <a:chOff x="969732" y="3069623"/>
                <a:chExt cx="2642616" cy="1892808"/>
              </a:xfrm>
            </p:grpSpPr>
            <p:pic>
              <p:nvPicPr>
                <p:cNvPr id="6146" name="Picture 2" descr="C:\Users\che9ff\Dropbox\LiV0 RGCs with Green Tuj1 and Red Brn3a--3\LiV0 RGCs with Green Tuj1 and Red Brn3a--3_c2.JPG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69732" y="3069623"/>
                  <a:ext cx="2642616" cy="18928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19" name="Straight Connector 18"/>
                <p:cNvCxnSpPr/>
                <p:nvPr/>
              </p:nvCxnSpPr>
              <p:spPr>
                <a:xfrm>
                  <a:off x="3124200" y="4800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TextBox 31"/>
              <p:cNvSpPr txBox="1"/>
              <p:nvPr/>
            </p:nvSpPr>
            <p:spPr>
              <a:xfrm>
                <a:off x="969732" y="4687670"/>
                <a:ext cx="26426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J-1</a:t>
                </a:r>
                <a:endPara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3265969" y="3064860"/>
              <a:ext cx="2701300" cy="1892808"/>
              <a:chOff x="3589253" y="3069623"/>
              <a:chExt cx="2705004" cy="1889626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3589253" y="3069623"/>
                <a:ext cx="2646650" cy="1889626"/>
                <a:chOff x="3589253" y="3069623"/>
                <a:chExt cx="2646650" cy="1889626"/>
              </a:xfrm>
            </p:grpSpPr>
            <p:pic>
              <p:nvPicPr>
                <p:cNvPr id="6147" name="Picture 3" descr="C:\Users\che9ff\Dropbox\LiV0 RGCs with Green Tuj1 and Red Brn3a--3\LiV0 RGCs with Green Tuj1 and Red Brn3a--3_c1.JPG"/>
                <p:cNvPicPr preferRelativeResize="0">
                  <a:picLocks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89253" y="3069623"/>
                  <a:ext cx="2646650" cy="188962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20" name="Straight Connector 19"/>
                <p:cNvCxnSpPr/>
                <p:nvPr/>
              </p:nvCxnSpPr>
              <p:spPr>
                <a:xfrm>
                  <a:off x="5791200" y="4800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extBox 32"/>
              <p:cNvSpPr txBox="1"/>
              <p:nvPr/>
            </p:nvSpPr>
            <p:spPr>
              <a:xfrm>
                <a:off x="3653746" y="4679272"/>
                <a:ext cx="26405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N3a</a:t>
                </a:r>
                <a:endPara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5940369" y="3067248"/>
              <a:ext cx="2670690" cy="1917511"/>
              <a:chOff x="6297095" y="3043476"/>
              <a:chExt cx="2670690" cy="1914287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6297095" y="3043476"/>
                <a:ext cx="2643642" cy="1889626"/>
                <a:chOff x="6297095" y="3043476"/>
                <a:chExt cx="2643642" cy="1889626"/>
              </a:xfrm>
            </p:grpSpPr>
            <p:pic>
              <p:nvPicPr>
                <p:cNvPr id="6148" name="Picture 4" descr="C:\Users\che9ff\Dropbox\LiV0 RGCs with Green Tuj1 and Red Brn3a--3\LiV0 RGCs with Green Tuj1 and Red Brn3a--3_(c1+c2+c3).JPG"/>
                <p:cNvPicPr preferRelativeResize="0">
                  <a:picLocks noChangeArrowheads="1"/>
                </p:cNvPicPr>
                <p:nvPr/>
              </p:nvPicPr>
              <p:blipFill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297095" y="3043476"/>
                  <a:ext cx="2643642" cy="188962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21" name="Straight Connector 20"/>
                <p:cNvCxnSpPr/>
                <p:nvPr/>
              </p:nvCxnSpPr>
              <p:spPr>
                <a:xfrm>
                  <a:off x="8458200" y="4800600"/>
                  <a:ext cx="283464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TextBox 33"/>
              <p:cNvSpPr txBox="1"/>
              <p:nvPr/>
            </p:nvSpPr>
            <p:spPr>
              <a:xfrm>
                <a:off x="6326829" y="4680764"/>
                <a:ext cx="26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J-1 </a:t>
                </a:r>
                <a:r>
                  <a:rPr lang="en-US" sz="12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 </a:t>
                </a:r>
                <a:r>
                  <a:rPr lang="en-US" sz="12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N3a/ </a:t>
                </a:r>
                <a:r>
                  <a:rPr lang="en-US" sz="1200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12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9" name="TextBox 38"/>
          <p:cNvSpPr txBox="1"/>
          <p:nvPr/>
        </p:nvSpPr>
        <p:spPr>
          <a:xfrm>
            <a:off x="282569" y="925485"/>
            <a:ext cx="457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620000" y="6129051"/>
            <a:ext cx="1349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281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69" name="Group 7168"/>
          <p:cNvGrpSpPr/>
          <p:nvPr/>
        </p:nvGrpSpPr>
        <p:grpSpPr>
          <a:xfrm>
            <a:off x="398461" y="908523"/>
            <a:ext cx="8396741" cy="4196877"/>
            <a:chOff x="561751" y="586814"/>
            <a:chExt cx="8396741" cy="4196877"/>
          </a:xfrm>
        </p:grpSpPr>
        <p:sp>
          <p:nvSpPr>
            <p:cNvPr id="15" name="TextBox 14"/>
            <p:cNvSpPr txBox="1"/>
            <p:nvPr/>
          </p:nvSpPr>
          <p:spPr>
            <a:xfrm>
              <a:off x="1350703" y="586814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TUJ-1</a:t>
              </a:r>
              <a:endParaRPr lang="en-US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030596" y="587072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ISLET-1</a:t>
              </a:r>
              <a:endParaRPr lang="en-US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704770" y="587947"/>
              <a:ext cx="1828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Merged</a:t>
              </a:r>
              <a:endParaRPr lang="en-US" b="1" dirty="0"/>
            </a:p>
          </p:txBody>
        </p:sp>
        <p:grpSp>
          <p:nvGrpSpPr>
            <p:cNvPr id="7168" name="Group 7167"/>
            <p:cNvGrpSpPr/>
            <p:nvPr/>
          </p:nvGrpSpPr>
          <p:grpSpPr>
            <a:xfrm>
              <a:off x="561751" y="964186"/>
              <a:ext cx="8396741" cy="3819505"/>
              <a:chOff x="561751" y="964186"/>
              <a:chExt cx="8396741" cy="3819505"/>
            </a:xfrm>
          </p:grpSpPr>
          <p:sp>
            <p:nvSpPr>
              <p:cNvPr id="3" name="TextBox 2"/>
              <p:cNvSpPr txBox="1"/>
              <p:nvPr/>
            </p:nvSpPr>
            <p:spPr>
              <a:xfrm rot="16200000">
                <a:off x="182537" y="1725924"/>
                <a:ext cx="11277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/>
                  <a:t>Control</a:t>
                </a:r>
                <a:endParaRPr lang="en-US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6200000">
                <a:off x="183120" y="3648126"/>
                <a:ext cx="11277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/>
                  <a:t>V0</a:t>
                </a:r>
                <a:endParaRPr lang="en-US" b="1" dirty="0"/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3615148" y="964301"/>
                <a:ext cx="2642616" cy="1895100"/>
                <a:chOff x="3615148" y="964301"/>
                <a:chExt cx="2642616" cy="1895100"/>
              </a:xfrm>
            </p:grpSpPr>
            <p:pic>
              <p:nvPicPr>
                <p:cNvPr id="7171" name="Picture 3" descr="C:\Users\che9ff\Dropbox\Normal RGCs with Green Tuj1 and Red Islet1--6\Normal RGCs with Green Tuj1 and Red Islet1--6_Texasred.JPG"/>
                <p:cNvPicPr>
                  <a:picLocks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730" t="33598" r="32169" b="8628"/>
                <a:stretch/>
              </p:blipFill>
              <p:spPr bwMode="auto">
                <a:xfrm>
                  <a:off x="3615148" y="964301"/>
                  <a:ext cx="2642616" cy="18928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22" name="Straight Connector 21"/>
                <p:cNvCxnSpPr/>
                <p:nvPr/>
              </p:nvCxnSpPr>
              <p:spPr>
                <a:xfrm>
                  <a:off x="5458305" y="2667000"/>
                  <a:ext cx="548640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/>
                <p:cNvSpPr txBox="1"/>
                <p:nvPr/>
              </p:nvSpPr>
              <p:spPr>
                <a:xfrm>
                  <a:off x="3615148" y="2582402"/>
                  <a:ext cx="26426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SLET-1</a:t>
                  </a:r>
                  <a:endPara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6287298" y="964186"/>
                <a:ext cx="2671194" cy="1892808"/>
                <a:chOff x="6258720" y="959423"/>
                <a:chExt cx="2671194" cy="1892808"/>
              </a:xfrm>
            </p:grpSpPr>
            <p:grpSp>
              <p:nvGrpSpPr>
                <p:cNvPr id="6" name="Group 5"/>
                <p:cNvGrpSpPr/>
                <p:nvPr/>
              </p:nvGrpSpPr>
              <p:grpSpPr>
                <a:xfrm>
                  <a:off x="6258720" y="959423"/>
                  <a:ext cx="2642616" cy="1892808"/>
                  <a:chOff x="6258720" y="959423"/>
                  <a:chExt cx="2642616" cy="1892808"/>
                </a:xfrm>
              </p:grpSpPr>
              <p:pic>
                <p:nvPicPr>
                  <p:cNvPr id="7172" name="Picture 4" descr="C:\Users\che9ff\Dropbox\Normal RGCs with Green Tuj1 and Red Islet1--6\Normal RGCs with Green Tuj1 and Red Islet1--6_(Texasred+Alexa 488+DAPI).JPG"/>
                  <p:cNvPicPr>
                    <a:picLocks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bright="4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116" t="18041" r="22333" b="18141"/>
                  <a:stretch/>
                </p:blipFill>
                <p:spPr bwMode="auto">
                  <a:xfrm>
                    <a:off x="6258720" y="959423"/>
                    <a:ext cx="2642616" cy="189280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14" name="Straight Connector 13"/>
                  <p:cNvCxnSpPr/>
                  <p:nvPr/>
                </p:nvCxnSpPr>
                <p:spPr>
                  <a:xfrm>
                    <a:off x="8125305" y="2667000"/>
                    <a:ext cx="548640" cy="0"/>
                  </a:xfrm>
                  <a:prstGeom prst="line">
                    <a:avLst/>
                  </a:prstGeom>
                  <a:ln w="349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8" name="TextBox 27"/>
                <p:cNvSpPr txBox="1"/>
                <p:nvPr/>
              </p:nvSpPr>
              <p:spPr>
                <a:xfrm>
                  <a:off x="6287298" y="2574368"/>
                  <a:ext cx="26426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J-1 / </a:t>
                  </a:r>
                  <a:r>
                    <a:rPr lang="en-US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SLET-1 / </a:t>
                  </a:r>
                  <a:r>
                    <a:rPr lang="en-US" sz="1200" b="1" dirty="0" smtClean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US" sz="1200" b="1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942851" y="2886388"/>
                <a:ext cx="2642616" cy="1897303"/>
                <a:chOff x="942851" y="2881625"/>
                <a:chExt cx="2642616" cy="1897303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942851" y="2881625"/>
                  <a:ext cx="2642616" cy="1892808"/>
                  <a:chOff x="942851" y="2881625"/>
                  <a:chExt cx="2642616" cy="1892808"/>
                </a:xfrm>
              </p:grpSpPr>
              <p:pic>
                <p:nvPicPr>
                  <p:cNvPr id="7173" name="Picture 5" descr="C:\Users\che9ff\Dropbox\LiV0 RGCs with Green Tuj1 and Red Islet1-1\LiV0 RGCs with Green Tuj1 and Red Islet1--1_c2.JPG"/>
                  <p:cNvPicPr>
                    <a:picLocks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777" t="23847" r="18949" b="3124"/>
                  <a:stretch/>
                </p:blipFill>
                <p:spPr bwMode="auto">
                  <a:xfrm>
                    <a:off x="942851" y="2881625"/>
                    <a:ext cx="2642616" cy="189280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25" name="Straight Connector 24"/>
                  <p:cNvCxnSpPr/>
                  <p:nvPr/>
                </p:nvCxnSpPr>
                <p:spPr>
                  <a:xfrm>
                    <a:off x="2775505" y="4572000"/>
                    <a:ext cx="548640" cy="0"/>
                  </a:xfrm>
                  <a:prstGeom prst="line">
                    <a:avLst/>
                  </a:prstGeom>
                  <a:ln w="349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" name="TextBox 28"/>
                <p:cNvSpPr txBox="1"/>
                <p:nvPr/>
              </p:nvSpPr>
              <p:spPr>
                <a:xfrm>
                  <a:off x="942852" y="4501929"/>
                  <a:ext cx="26426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J-1</a:t>
                  </a:r>
                  <a:endParaRPr lang="en-US" sz="12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3615148" y="2886388"/>
                <a:ext cx="2642617" cy="1893668"/>
                <a:chOff x="3615148" y="2881625"/>
                <a:chExt cx="2642617" cy="1893668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3615148" y="2881625"/>
                  <a:ext cx="2642616" cy="1892808"/>
                  <a:chOff x="3615148" y="2881625"/>
                  <a:chExt cx="2642616" cy="1892808"/>
                </a:xfrm>
              </p:grpSpPr>
              <p:pic>
                <p:nvPicPr>
                  <p:cNvPr id="7174" name="Picture 6" descr="C:\Users\che9ff\Dropbox\LiV0 RGCs with Green Tuj1 and Red Islet1-1\LiV0 RGCs with Green Tuj1 and Red Islet1--1_c1.JPG"/>
                  <p:cNvPicPr>
                    <a:picLocks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11220"/>
                  <a:stretch/>
                </p:blipFill>
                <p:spPr bwMode="auto">
                  <a:xfrm>
                    <a:off x="3615148" y="2881625"/>
                    <a:ext cx="2642616" cy="189280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23" name="Straight Connector 22"/>
                  <p:cNvCxnSpPr/>
                  <p:nvPr/>
                </p:nvCxnSpPr>
                <p:spPr>
                  <a:xfrm>
                    <a:off x="5458025" y="4572000"/>
                    <a:ext cx="548640" cy="0"/>
                  </a:xfrm>
                  <a:prstGeom prst="line">
                    <a:avLst/>
                  </a:prstGeom>
                  <a:ln w="349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0" name="TextBox 29"/>
                <p:cNvSpPr txBox="1"/>
                <p:nvPr/>
              </p:nvSpPr>
              <p:spPr>
                <a:xfrm>
                  <a:off x="3615149" y="4498294"/>
                  <a:ext cx="26426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SLET-1</a:t>
                  </a:r>
                  <a:endPara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6287298" y="2886388"/>
                <a:ext cx="2642616" cy="1895160"/>
                <a:chOff x="6287298" y="2881625"/>
                <a:chExt cx="2642616" cy="1895160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6287298" y="2881625"/>
                  <a:ext cx="2642616" cy="1892808"/>
                  <a:chOff x="6287298" y="2881625"/>
                  <a:chExt cx="2642616" cy="1892808"/>
                </a:xfrm>
              </p:grpSpPr>
              <p:pic>
                <p:nvPicPr>
                  <p:cNvPr id="7175" name="Picture 7" descr="C:\Users\che9ff\Dropbox\LiV0 RGCs with Green Tuj1 and Red Islet1-1\LiV0 RGCs with Green Tuj1 and Red Islet1--1_(c1+c2+c3).JPG"/>
                  <p:cNvPicPr>
                    <a:picLocks noChangeArrowheads="1"/>
                  </p:cNvPicPr>
                  <p:nvPr/>
                </p:nvPicPr>
                <p:blipFill rotWithShape="1">
                  <a:blip r:embed="rId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708" t="26832" r="20254" b="2512"/>
                  <a:stretch/>
                </p:blipFill>
                <p:spPr bwMode="auto">
                  <a:xfrm>
                    <a:off x="6287298" y="2881625"/>
                    <a:ext cx="2642616" cy="189280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20" name="Straight Connector 19"/>
                  <p:cNvCxnSpPr/>
                  <p:nvPr/>
                </p:nvCxnSpPr>
                <p:spPr>
                  <a:xfrm>
                    <a:off x="8125025" y="4572000"/>
                    <a:ext cx="548640" cy="0"/>
                  </a:xfrm>
                  <a:prstGeom prst="line">
                    <a:avLst/>
                  </a:prstGeom>
                  <a:ln w="349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1" name="TextBox 30"/>
                <p:cNvSpPr txBox="1"/>
                <p:nvPr/>
              </p:nvSpPr>
              <p:spPr>
                <a:xfrm>
                  <a:off x="6287298" y="4499786"/>
                  <a:ext cx="26426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J-1 / </a:t>
                  </a:r>
                  <a:r>
                    <a:rPr lang="en-US" sz="12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SLET-1 / </a:t>
                  </a:r>
                  <a:r>
                    <a:rPr lang="en-US" sz="1200" b="1" dirty="0" smtClean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US" sz="1200" b="1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942851" y="964300"/>
                <a:ext cx="2642616" cy="1893973"/>
                <a:chOff x="942851" y="964300"/>
                <a:chExt cx="2642616" cy="1893973"/>
              </a:xfrm>
            </p:grpSpPr>
            <p:pic>
              <p:nvPicPr>
                <p:cNvPr id="7170" name="Picture 2" descr="C:\Users\che9ff\Dropbox\Normal RGCs with Green Tuj1 and Red Islet1--6\Normal RGCs with Green Tuj1 and Red Islet1--6_Alexa 488.JPG"/>
                <p:cNvPicPr>
                  <a:picLocks noChangeArrowheads="1"/>
                </p:cNvPicPr>
                <p:nvPr/>
              </p:nvPicPr>
              <p:blipFill rotWithShape="1"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468" t="16286" r="21902" b="16887"/>
                <a:stretch/>
              </p:blipFill>
              <p:spPr bwMode="auto">
                <a:xfrm>
                  <a:off x="942851" y="964300"/>
                  <a:ext cx="2642616" cy="18928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24" name="Straight Connector 23"/>
                <p:cNvCxnSpPr/>
                <p:nvPr/>
              </p:nvCxnSpPr>
              <p:spPr>
                <a:xfrm>
                  <a:off x="2775785" y="2667000"/>
                  <a:ext cx="548640" cy="0"/>
                </a:xfrm>
                <a:prstGeom prst="line">
                  <a:avLst/>
                </a:prstGeom>
                <a:ln w="349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5"/>
                <p:cNvSpPr txBox="1"/>
                <p:nvPr/>
              </p:nvSpPr>
              <p:spPr>
                <a:xfrm>
                  <a:off x="942851" y="2581274"/>
                  <a:ext cx="26426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J-1</a:t>
                  </a:r>
                  <a:endParaRPr lang="en-US" sz="12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38" name="TextBox 37"/>
          <p:cNvSpPr txBox="1"/>
          <p:nvPr/>
        </p:nvSpPr>
        <p:spPr>
          <a:xfrm>
            <a:off x="315684" y="1029277"/>
            <a:ext cx="457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620000" y="6129051"/>
            <a:ext cx="1349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4504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1000" y="2286000"/>
            <a:ext cx="8382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analysis of RGCs derived from the Control and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SCs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day 38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sphere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plated onto PLO/L-coated plates and cultured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S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dium containing 10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T and 10% FBS for 21 d before fixation with 4% PFA on day 38. Cells were stained with TUJ1 (gree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BRN3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SLET-1 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ale bars equal 20 µM.</a:t>
            </a:r>
          </a:p>
        </p:txBody>
      </p:sp>
    </p:spTree>
    <p:extLst>
      <p:ext uri="{BB962C8B-B14F-4D97-AF65-F5344CB8AC3E}">
        <p14:creationId xmlns:p14="http://schemas.microsoft.com/office/powerpoint/2010/main" val="1925601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che9ff\Desktop\12-28-2014\Olivia-NIM-Brn3a-1\Olivia-NIM-Brn3a-1_c2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685800"/>
            <a:ext cx="2949233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che9ff\Desktop\12-28-2014\Olivia-NIM-Brn3a-1\Olivia-NIM-Brn3a-1_c1.BMP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253" y="685800"/>
            <a:ext cx="2949232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che9ff\Desktop\12-28-2014\Olivia-NIM-Brn3a-1\Olivia-NIM-Brn3a-1_(c1+c2+c3).BMP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9915" y="681990"/>
            <a:ext cx="2954318" cy="2213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che9ff\Desktop\12-28-2014\Olivia-NIM-ISLET1-1\Olivia-NIM-ISLET1-1_c2.BMP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2907029"/>
            <a:ext cx="2949233" cy="22155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che9ff\Desktop\12-28-2014\Olivia-NIM-ISLET1-1\Olivia-NIM-ISLET1-1_c1.BMP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254" y="2907030"/>
            <a:ext cx="2949232" cy="2219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C:\Users\che9ff\Desktop\12-28-2014\Olivia-NIM-ISLET1-1\Olivia-NIM-ISLET1-1_(c1+c2+c3).BMP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9915" y="2907030"/>
            <a:ext cx="2956851" cy="22155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52400" y="2590800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101340" y="2590800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67626" y="2590800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N3a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2400" y="4839533"/>
            <a:ext cx="2773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</a:t>
            </a:r>
            <a:endParaRPr lang="en-US" sz="14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12770" y="4839533"/>
            <a:ext cx="2793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67626" y="4839533"/>
            <a:ext cx="2794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-1 </a:t>
            </a:r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LET-1 / </a:t>
            </a:r>
            <a:r>
              <a:rPr lang="en-US" sz="1400" b="1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4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47993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04800" y="2220726"/>
            <a:ext cx="86106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NIM promoted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  <a:r>
              <a:rPr lang="en-US" sz="14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GC-OL generation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by</a:t>
            </a:r>
            <a:r>
              <a:rPr kumimoji="0" lang="en-US" altLang="en-US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IF.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utative 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L-</a:t>
            </a:r>
            <a:r>
              <a:rPr kumimoji="0" lang="en-US" alt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GCs 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derived from </a:t>
            </a:r>
            <a:r>
              <a:rPr kumimoji="0" lang="en-US" alt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L-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iPSCs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were cultured with 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ESC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medium containing 10 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  <a:ea typeface="SimSun" pitchFamily="2" charset="-122"/>
                <a:cs typeface="Times New Roman" pitchFamily="18" charset="0"/>
              </a:rPr>
              <a:t>m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DAPT, 10% FBS, and 10% neural induction medium (NIM) for 14 d before fixation on day 31. Upper panel shows TUJ1 (green) and BRN3a (red) 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tainings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 Lower panel shows </a:t>
            </a:r>
            <a:r>
              <a:rPr lang="en-US" altLang="en-US" sz="1400" dirty="0" err="1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tainings</a:t>
            </a:r>
            <a:r>
              <a:rPr lang="en-US" altLang="en-US" sz="1400" dirty="0" smtClean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of TUJ1 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(green) and ISLET1 (red). The scale bars equal 50 µM.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0572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69</TotalTime>
  <Words>756</Words>
  <Application>Microsoft Office PowerPoint</Application>
  <PresentationFormat>On-screen Show (4:3)</PresentationFormat>
  <Paragraphs>81</Paragraphs>
  <Slides>1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Jing</dc:creator>
  <cp:lastModifiedBy>CCHMC</cp:lastModifiedBy>
  <cp:revision>38</cp:revision>
  <dcterms:created xsi:type="dcterms:W3CDTF">2006-08-16T00:00:00Z</dcterms:created>
  <dcterms:modified xsi:type="dcterms:W3CDTF">2015-05-12T03:30:27Z</dcterms:modified>
</cp:coreProperties>
</file>